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90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deto ueki" initials="hu" lastIdx="1" clrIdx="0">
    <p:extLst>
      <p:ext uri="{19B8F6BF-5375-455C-9EA6-DF929625EA0E}">
        <p15:presenceInfo xmlns:p15="http://schemas.microsoft.com/office/powerpoint/2012/main" userId="53e6805a4339c75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>
      <p:cViewPr varScale="1">
        <p:scale>
          <a:sx n="90" d="100"/>
          <a:sy n="90" d="100"/>
        </p:scale>
        <p:origin x="232" y="9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1D21AE-AB16-C84D-28E8-E1943DABE5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A5340A8-591A-99ED-2D03-D59978721F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9A21C1-8CDB-E19D-F92A-710E67471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94DB0B-E2E4-3B1A-5266-338A9C536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C023EC-2B19-F103-DCAF-42B459764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1487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314A90-CF6A-7AD1-F7F6-D32A603F61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C588EEF-31EB-CF9F-6C8C-D5E296F385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67226A-AD7A-C198-B093-16CC26EFD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5C07B3-6534-4450-3B35-3AB359398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91448B-E18F-992F-3BCB-ACB65910A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401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0E65D7C-FCA4-5744-CB64-9847A98796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7DC019D-16E0-9D50-0712-81F8C22FF0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50E934-498C-C31E-E56C-1E3761D36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443E67-23EA-FADD-DE09-730BD6F59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0ACDF8-7EFE-4880-5A57-9FC81EFC6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501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76034E-5FC9-FA29-F0AD-51530F690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FC71708-2C49-47B0-9265-F2858523CB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6EB43A-7404-FF2C-7120-2885AD9F7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9B1FB9-8DA7-6132-8651-412E196FD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3D4ECF-C3E8-B2CC-350D-56A6AE123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21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6A04D2-96B0-99C7-D062-2DDBDE2F5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5F12A6-F988-740E-D472-F6781E24B1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A989EB-529C-09BF-52F0-C05A3331E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1CFD82-ACAF-6CBC-DA98-4810F7C80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7603F0-B874-117D-49B9-32C8D5D79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0622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5096A7-6E1F-6C7B-F279-C09B8FD20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B5834DE-5161-E9A2-83C8-F400C280A3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A211B7F-66B2-8344-FCDD-D43332FC6F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FF41A2-4950-CB98-300E-3702E385A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2374E6-B7AC-1E50-4EF5-843A8312C8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BBDA64-6064-94D1-AD4E-C147AF49F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392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C002EE-565A-B56C-3859-2EC928F4E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B8E169B-ACFD-2247-ED6A-7B14430245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BE077CA-E673-921C-5FA0-BFE946BAF4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C8BC725-DC72-0797-573C-F392C717F3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ACA19E0-E73D-C43B-FDCF-3B41B68895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B858A6E-BB09-3F03-F641-36A34303A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958790B-4682-0DB1-33DE-FE81DC686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2FDE515-2DB4-6D50-A3EA-F5B870DB6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081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8BB3A2-B7E0-B3D7-B439-F671607894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E284660-5A8B-4701-8ABA-C652277C6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D488CF2-294F-4AF2-5CF2-F377F533E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2ACF8A7-C55F-C124-BDD0-069D7B631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5825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8162AF0-E3AC-330A-0A52-461C70B7E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C39E4A2-BDF8-C5DA-AC0C-1CFEA862A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402E410-10AC-5B79-A576-A4A12799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656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6BAEE8-D009-4E8F-A2BE-2B2768210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BEB486B-C95F-D923-9DAE-0FEAFD5E07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F0F15E2-1C15-6C34-2779-A2FC6B6A73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704C2D7-48C9-C26B-20D5-18992F9C0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E7BFDD-C1ED-A1BD-833F-8E0C01997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D5DF241-40F7-7368-6B06-E3306A23E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869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A1AC6D-8894-08BC-4FD0-610563858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4B77B52-004D-3475-378F-C942BCB6DA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BF6F2B2-DC6F-6CDC-C0F8-7EFD7A2B9F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8799D08-57BA-76F5-02A2-3161ADDFA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4750220-0FE3-612F-57AF-6EB6E36212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0CBCF12-C9A6-9C02-4E7C-1353DACA9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526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CFBBF43-52D0-0092-C7A3-A00D17C33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40AE947-0BC5-3E84-9722-24E3EE9718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E5D768-AB38-A09C-A70E-64DFEBAB30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442ED-2DD8-DB40-9422-5D798BA9687F}" type="datetimeFigureOut">
              <a:rPr kumimoji="1" lang="ja-JP" altLang="en-US" smtClean="0"/>
              <a:t>2023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A37195-D2E2-C6DA-5F49-77695B5BED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E38987-D271-952E-D496-642DFD0D81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10670C-B795-EE41-8D88-973326FBC5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392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4E44CE-C7BB-41BB-9E43-0027CE5C4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4344" y="17795"/>
            <a:ext cx="3831999" cy="1325563"/>
          </a:xfrm>
        </p:spPr>
        <p:txBody>
          <a:bodyPr>
            <a:normAutofit/>
          </a:bodyPr>
          <a:lstStyle/>
          <a:p>
            <a:r>
              <a:rPr lang="en" altLang="ja-JP" sz="2400" u="sng" dirty="0">
                <a:latin typeface="Arial" panose="020B0604020202020204" pitchFamily="34" charset="0"/>
                <a:cs typeface="Arial" panose="020B0604020202020204" pitchFamily="34" charset="0"/>
              </a:rPr>
              <a:t>Supplemental Information</a:t>
            </a:r>
            <a:endParaRPr lang="ja-JP" altLang="en-US" sz="2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コンテンツ プレースホルダー 20" descr="グラフ, 散布図&#10;&#10;自動的に生成された説明">
            <a:extLst>
              <a:ext uri="{FF2B5EF4-FFF2-40B4-BE49-F238E27FC236}">
                <a16:creationId xmlns:a16="http://schemas.microsoft.com/office/drawing/2014/main" id="{029219FE-0CAC-491F-AB97-35479510D21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408824" y="1229182"/>
            <a:ext cx="1800000" cy="1800000"/>
          </a:xfrm>
        </p:spPr>
      </p:pic>
      <p:pic>
        <p:nvPicPr>
          <p:cNvPr id="6" name="図 5" descr="グラフ, ヒストグラム&#10;&#10;自動的に生成された説明">
            <a:extLst>
              <a:ext uri="{FF2B5EF4-FFF2-40B4-BE49-F238E27FC236}">
                <a16:creationId xmlns:a16="http://schemas.microsoft.com/office/drawing/2014/main" id="{E9A58B81-81BD-4ECC-8390-1E3B3DE782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5404" y="1229181"/>
            <a:ext cx="1805921" cy="1800000"/>
          </a:xfrm>
          <a:prstGeom prst="rect">
            <a:avLst/>
          </a:prstGeom>
        </p:spPr>
      </p:pic>
      <p:pic>
        <p:nvPicPr>
          <p:cNvPr id="8" name="図 7" descr="グラフ&#10;&#10;自動的に生成された説明">
            <a:extLst>
              <a:ext uri="{FF2B5EF4-FFF2-40B4-BE49-F238E27FC236}">
                <a16:creationId xmlns:a16="http://schemas.microsoft.com/office/drawing/2014/main" id="{2CD6E648-570C-4F3F-980C-DFAC95D97A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30924" y="1217194"/>
            <a:ext cx="1800000" cy="180000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63BC997-54AE-4563-8F3B-1AE72173CCCA}"/>
              </a:ext>
            </a:extLst>
          </p:cNvPr>
          <p:cNvSpPr txBox="1"/>
          <p:nvPr/>
        </p:nvSpPr>
        <p:spPr>
          <a:xfrm>
            <a:off x="8650386" y="600441"/>
            <a:ext cx="13227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ongum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20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PD-1+aCTLA-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9297DC1-F4AA-485F-B3A9-96F4913C08CC}"/>
              </a:ext>
            </a:extLst>
          </p:cNvPr>
          <p:cNvSpPr txBox="1"/>
          <p:nvPr/>
        </p:nvSpPr>
        <p:spPr>
          <a:xfrm>
            <a:off x="6747347" y="947396"/>
            <a:ext cx="13227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PD-1+aCTLA-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2422A3D-1A84-41AD-B8A4-4DD5378A7DA9}"/>
              </a:ext>
            </a:extLst>
          </p:cNvPr>
          <p:cNvSpPr txBox="1"/>
          <p:nvPr/>
        </p:nvSpPr>
        <p:spPr>
          <a:xfrm>
            <a:off x="5277003" y="954483"/>
            <a:ext cx="4924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16BFCE08-2F61-4D8F-ADCC-C9F5E63901F3}"/>
              </a:ext>
            </a:extLst>
          </p:cNvPr>
          <p:cNvCxnSpPr>
            <a:cxnSpLocks/>
          </p:cNvCxnSpPr>
          <p:nvPr/>
        </p:nvCxnSpPr>
        <p:spPr>
          <a:xfrm>
            <a:off x="4561620" y="3080339"/>
            <a:ext cx="5765221" cy="2397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DF226CC-5C47-4FFB-AEA2-98D8F5001E10}"/>
              </a:ext>
            </a:extLst>
          </p:cNvPr>
          <p:cNvSpPr txBox="1"/>
          <p:nvPr/>
        </p:nvSpPr>
        <p:spPr>
          <a:xfrm>
            <a:off x="7163326" y="3148492"/>
            <a:ext cx="490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BCC59E10-8086-4B98-8828-990BBAFB0242}"/>
              </a:ext>
            </a:extLst>
          </p:cNvPr>
          <p:cNvCxnSpPr>
            <a:cxnSpLocks/>
          </p:cNvCxnSpPr>
          <p:nvPr/>
        </p:nvCxnSpPr>
        <p:spPr>
          <a:xfrm flipV="1">
            <a:off x="4565804" y="1033124"/>
            <a:ext cx="0" cy="204721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14C4EFF-C798-460D-A761-58E5C9591C57}"/>
              </a:ext>
            </a:extLst>
          </p:cNvPr>
          <p:cNvSpPr txBox="1"/>
          <p:nvPr/>
        </p:nvSpPr>
        <p:spPr>
          <a:xfrm rot="16200000">
            <a:off x="4139422" y="195957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8C12676-D359-5E02-4020-ABCA7A414947}"/>
              </a:ext>
            </a:extLst>
          </p:cNvPr>
          <p:cNvSpPr txBox="1"/>
          <p:nvPr/>
        </p:nvSpPr>
        <p:spPr>
          <a:xfrm>
            <a:off x="373819" y="2423357"/>
            <a:ext cx="295789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Fig. S1) Representative dot plots of FMC analysis for TIL in </a:t>
            </a:r>
            <a:r>
              <a:rPr lang="en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Renca</a:t>
            </a: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tumor tissues.</a:t>
            </a:r>
          </a:p>
          <a:p>
            <a:endParaRPr lang="en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dot plots and gating of flow cytometric (FCM) analysis for tumor infiltrating lymphocytes (TILs) in </a:t>
            </a:r>
            <a:r>
              <a:rPr lang="en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Renca</a:t>
            </a: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tumors after combination therapy with B. longum 420 and anti-PD-1 antibody.</a:t>
            </a:r>
          </a:p>
        </p:txBody>
      </p:sp>
      <p:pic>
        <p:nvPicPr>
          <p:cNvPr id="25" name="図 24" descr="グラフ, 散布図&#10;&#10;自動的に生成された説明">
            <a:extLst>
              <a:ext uri="{FF2B5EF4-FFF2-40B4-BE49-F238E27FC236}">
                <a16:creationId xmlns:a16="http://schemas.microsoft.com/office/drawing/2014/main" id="{432BDEBD-FD42-C986-95F0-E0CAE2A6E5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18127" y="4292203"/>
            <a:ext cx="1800000" cy="1800000"/>
          </a:xfrm>
          <a:prstGeom prst="rect">
            <a:avLst/>
          </a:prstGeom>
        </p:spPr>
      </p:pic>
      <p:pic>
        <p:nvPicPr>
          <p:cNvPr id="26" name="図 25" descr="グラフ&#10;&#10;自動的に生成された説明">
            <a:extLst>
              <a:ext uri="{FF2B5EF4-FFF2-40B4-BE49-F238E27FC236}">
                <a16:creationId xmlns:a16="http://schemas.microsoft.com/office/drawing/2014/main" id="{9E4E5B19-6284-4CE2-21C5-9026BC9B7FD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28543" y="4280189"/>
            <a:ext cx="1817940" cy="1800000"/>
          </a:xfrm>
          <a:prstGeom prst="rect">
            <a:avLst/>
          </a:prstGeom>
        </p:spPr>
      </p:pic>
      <p:pic>
        <p:nvPicPr>
          <p:cNvPr id="27" name="図 26" descr="グラフ, 箱ひげ図&#10;&#10;自動的に生成された説明">
            <a:extLst>
              <a:ext uri="{FF2B5EF4-FFF2-40B4-BE49-F238E27FC236}">
                <a16:creationId xmlns:a16="http://schemas.microsoft.com/office/drawing/2014/main" id="{A51CCF4F-6042-646B-7C60-EA6FEAB1032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35266" y="4275419"/>
            <a:ext cx="1794078" cy="18000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A4E6D77-2ACF-4820-1C69-82876F7B6122}"/>
              </a:ext>
            </a:extLst>
          </p:cNvPr>
          <p:cNvSpPr txBox="1"/>
          <p:nvPr/>
        </p:nvSpPr>
        <p:spPr>
          <a:xfrm>
            <a:off x="7213098" y="6161757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70F7468-52D3-7F79-C789-B51CB7B917EE}"/>
              </a:ext>
            </a:extLst>
          </p:cNvPr>
          <p:cNvSpPr txBox="1"/>
          <p:nvPr/>
        </p:nvSpPr>
        <p:spPr>
          <a:xfrm rot="16200000">
            <a:off x="4010403" y="4946878"/>
            <a:ext cx="745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D107a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205EE71-E3CC-CE16-1DF9-D96CD04E6CFC}"/>
              </a:ext>
            </a:extLst>
          </p:cNvPr>
          <p:cNvSpPr txBox="1"/>
          <p:nvPr/>
        </p:nvSpPr>
        <p:spPr>
          <a:xfrm>
            <a:off x="8664674" y="3629088"/>
            <a:ext cx="13227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ongum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20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PD-1+aCTLA-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8EE551E-B96E-E55C-D8AF-DA1E7FF7352B}"/>
              </a:ext>
            </a:extLst>
          </p:cNvPr>
          <p:cNvSpPr txBox="1"/>
          <p:nvPr/>
        </p:nvSpPr>
        <p:spPr>
          <a:xfrm>
            <a:off x="6761635" y="3976043"/>
            <a:ext cx="13227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PD-1+aCTLA-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865EA9F-6E95-EBE2-EF49-22AA8FE380F2}"/>
              </a:ext>
            </a:extLst>
          </p:cNvPr>
          <p:cNvSpPr txBox="1"/>
          <p:nvPr/>
        </p:nvSpPr>
        <p:spPr>
          <a:xfrm>
            <a:off x="5291291" y="3983130"/>
            <a:ext cx="4924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4A9DFEA9-23CD-6645-3001-D08A3E403611}"/>
              </a:ext>
            </a:extLst>
          </p:cNvPr>
          <p:cNvCxnSpPr>
            <a:cxnSpLocks/>
          </p:cNvCxnSpPr>
          <p:nvPr/>
        </p:nvCxnSpPr>
        <p:spPr>
          <a:xfrm>
            <a:off x="4575908" y="6108986"/>
            <a:ext cx="5765221" cy="2397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78C50746-30FB-C263-FA95-9B737788C977}"/>
              </a:ext>
            </a:extLst>
          </p:cNvPr>
          <p:cNvCxnSpPr>
            <a:cxnSpLocks/>
          </p:cNvCxnSpPr>
          <p:nvPr/>
        </p:nvCxnSpPr>
        <p:spPr>
          <a:xfrm flipV="1">
            <a:off x="4580092" y="4061771"/>
            <a:ext cx="0" cy="204721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5602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82</Words>
  <Application>Microsoft Macintosh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Supplemental Inform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</dc:title>
  <dc:creator>植木　秀登</dc:creator>
  <cp:lastModifiedBy>植木　秀登</cp:lastModifiedBy>
  <cp:revision>3</cp:revision>
  <dcterms:created xsi:type="dcterms:W3CDTF">2023-05-23T21:50:29Z</dcterms:created>
  <dcterms:modified xsi:type="dcterms:W3CDTF">2023-05-23T22:27:08Z</dcterms:modified>
</cp:coreProperties>
</file>